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53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07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855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300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407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321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52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098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63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55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220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006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14C599-D3B3-4B8D-8E85-44F1113788B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172B9-692F-4C81-90BF-B65988EC6A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443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8589" y="914400"/>
            <a:ext cx="8623066" cy="460682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829734" y="5772118"/>
            <a:ext cx="1100666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27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xanthones against sensitive strain D6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2-hydroxanthone, 1,3-dihydroxyxanthone, 2,3,4,5,6- pentaacetylxanthone were active against </a:t>
            </a:r>
            <a:r>
              <a:rPr kumimoji="0" lang="en-US" altLang="en-US" sz="1200" b="0" i="1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P. falciparum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D6 strain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ranged from 0.075 – 75 µM) but did not possess the anti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&gt; 1000 µM)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705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7:56Z</dcterms:created>
  <dcterms:modified xsi:type="dcterms:W3CDTF">2020-08-04T16:37:09Z</dcterms:modified>
</cp:coreProperties>
</file>